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84" r:id="rId2"/>
    <p:sldId id="283" r:id="rId3"/>
    <p:sldId id="285" r:id="rId4"/>
    <p:sldId id="287" r:id="rId5"/>
    <p:sldId id="286" r:id="rId6"/>
  </p:sldIdLst>
  <p:sldSz cx="6480175" cy="62103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682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W Tsai" userId="89b631702f483e63" providerId="LiveId" clId="{B9B6886E-0450-4925-BFEA-F01AFD5ECEFE}"/>
    <pc:docChg chg="custSel modSld">
      <pc:chgData name="YW Tsai" userId="89b631702f483e63" providerId="LiveId" clId="{B9B6886E-0450-4925-BFEA-F01AFD5ECEFE}" dt="2025-09-14T12:31:03.741" v="1" actId="207"/>
      <pc:docMkLst>
        <pc:docMk/>
      </pc:docMkLst>
      <pc:sldChg chg="modSp mod">
        <pc:chgData name="YW Tsai" userId="89b631702f483e63" providerId="LiveId" clId="{B9B6886E-0450-4925-BFEA-F01AFD5ECEFE}" dt="2025-09-14T12:31:03.741" v="1" actId="207"/>
        <pc:sldMkLst>
          <pc:docMk/>
          <pc:sldMk cId="2512582539" sldId="284"/>
        </pc:sldMkLst>
        <pc:graphicFrameChg chg="modGraphic">
          <ac:chgData name="YW Tsai" userId="89b631702f483e63" providerId="LiveId" clId="{B9B6886E-0450-4925-BFEA-F01AFD5ECEFE}" dt="2025-09-14T12:31:03.741" v="1" actId="207"/>
          <ac:graphicFrameMkLst>
            <pc:docMk/>
            <pc:sldMk cId="2512582539" sldId="284"/>
            <ac:graphicFrameMk id="7" creationId="{B70B6979-904E-2D96-4591-43B368700E0B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016362"/>
            <a:ext cx="5508149" cy="2162104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261846"/>
            <a:ext cx="4860131" cy="149938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22B6D-37FC-4C77-80C1-CCABA02D1C09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70842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E46A1-A0DF-439D-8DF5-8F18FB5D6CA1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0123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30641"/>
            <a:ext cx="1397288" cy="5262942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30641"/>
            <a:ext cx="4110861" cy="5262942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9CB08-FD68-46AE-95EB-173515EE69C4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1486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CFA95-E145-460E-B930-C3E181DF0A4F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597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548264"/>
            <a:ext cx="5589151" cy="2583312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156015"/>
            <a:ext cx="5589151" cy="1358503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82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7EB40-C2F2-4B6A-B1F4-5725ADF0910D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313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653205"/>
            <a:ext cx="2754074" cy="394037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653205"/>
            <a:ext cx="2754074" cy="394037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BFCF9-D4EA-422D-9FD5-7A4FB84D9EE0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13029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30642"/>
            <a:ext cx="5589151" cy="1200371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522387"/>
            <a:ext cx="2741417" cy="74609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268485"/>
            <a:ext cx="2741417" cy="333659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522387"/>
            <a:ext cx="2754918" cy="74609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268485"/>
            <a:ext cx="2754918" cy="333659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2702-572B-44D9-9208-F3B70B23F0B4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5233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01B37-5B28-41AE-9F90-BB05EEEF9C8C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04628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2F96-ACBB-4089-9EBE-12AA7B9146C4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44641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14020"/>
            <a:ext cx="2090025" cy="144907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894170"/>
            <a:ext cx="3280589" cy="4413338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63090"/>
            <a:ext cx="2090025" cy="345160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8BE60-56EA-4EA7-949B-177BCF402BA4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55234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14020"/>
            <a:ext cx="2090025" cy="144907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894170"/>
            <a:ext cx="3280589" cy="4413338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863090"/>
            <a:ext cx="2090025" cy="345160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7E16E-8FE4-42DA-A063-7E604D610429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56111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30642"/>
            <a:ext cx="5589151" cy="12003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653205"/>
            <a:ext cx="5589151" cy="39403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5756029"/>
            <a:ext cx="1458039" cy="3306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E44298-27FB-45F0-98FB-58AF82AB1DDA}" type="datetime1">
              <a:rPr lang="zh-TW" altLang="en-US" smtClean="0"/>
              <a:t>2025/9/1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5756029"/>
            <a:ext cx="2187059" cy="3306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5756029"/>
            <a:ext cx="1458039" cy="3306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BF8ACE-5F9E-4525-94E8-A111154E6F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3082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4F537C-CCE5-DAB0-9413-B3966D72DC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>
            <a:extLst>
              <a:ext uri="{FF2B5EF4-FFF2-40B4-BE49-F238E27FC236}">
                <a16:creationId xmlns:a16="http://schemas.microsoft.com/office/drawing/2014/main" id="{9614EE26-E6B5-8148-A982-D15969C7B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12014" y="5719815"/>
            <a:ext cx="1458039" cy="330641"/>
          </a:xfrm>
        </p:spPr>
        <p:txBody>
          <a:bodyPr/>
          <a:lstStyle/>
          <a:p>
            <a:r>
              <a:rPr lang="en-US" altLang="zh-TW" dirty="0">
                <a:solidFill>
                  <a:schemeClr val="tx1"/>
                </a:solidFill>
              </a:rPr>
              <a:t>4</a:t>
            </a:r>
            <a:endParaRPr lang="zh-TW" altLang="en-US" dirty="0">
              <a:solidFill>
                <a:schemeClr val="tx1"/>
              </a:solidFill>
            </a:endParaRPr>
          </a:p>
        </p:txBody>
      </p:sp>
      <p:graphicFrame>
        <p:nvGraphicFramePr>
          <p:cNvPr id="7" name="內容版面配置區 4">
            <a:extLst>
              <a:ext uri="{FF2B5EF4-FFF2-40B4-BE49-F238E27FC236}">
                <a16:creationId xmlns:a16="http://schemas.microsoft.com/office/drawing/2014/main" id="{B70B6979-904E-2D96-4591-43B368700E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0131761"/>
              </p:ext>
            </p:extLst>
          </p:nvPr>
        </p:nvGraphicFramePr>
        <p:xfrm>
          <a:off x="53666" y="816648"/>
          <a:ext cx="6372842" cy="4805549"/>
        </p:xfrm>
        <a:graphic>
          <a:graphicData uri="http://schemas.openxmlformats.org/drawingml/2006/table">
            <a:tbl>
              <a:tblPr/>
              <a:tblGrid>
                <a:gridCol w="2331038">
                  <a:extLst>
                    <a:ext uri="{9D8B030D-6E8A-4147-A177-3AD203B41FA5}">
                      <a16:colId xmlns:a16="http://schemas.microsoft.com/office/drawing/2014/main" val="3114476739"/>
                    </a:ext>
                  </a:extLst>
                </a:gridCol>
                <a:gridCol w="727741">
                  <a:extLst>
                    <a:ext uri="{9D8B030D-6E8A-4147-A177-3AD203B41FA5}">
                      <a16:colId xmlns:a16="http://schemas.microsoft.com/office/drawing/2014/main" val="2275504669"/>
                    </a:ext>
                  </a:extLst>
                </a:gridCol>
                <a:gridCol w="812787">
                  <a:extLst>
                    <a:ext uri="{9D8B030D-6E8A-4147-A177-3AD203B41FA5}">
                      <a16:colId xmlns:a16="http://schemas.microsoft.com/office/drawing/2014/main" val="2710017980"/>
                    </a:ext>
                  </a:extLst>
                </a:gridCol>
                <a:gridCol w="29244">
                  <a:extLst>
                    <a:ext uri="{9D8B030D-6E8A-4147-A177-3AD203B41FA5}">
                      <a16:colId xmlns:a16="http://schemas.microsoft.com/office/drawing/2014/main" val="1451210055"/>
                    </a:ext>
                  </a:extLst>
                </a:gridCol>
                <a:gridCol w="671455">
                  <a:extLst>
                    <a:ext uri="{9D8B030D-6E8A-4147-A177-3AD203B41FA5}">
                      <a16:colId xmlns:a16="http://schemas.microsoft.com/office/drawing/2014/main" val="2740415642"/>
                    </a:ext>
                  </a:extLst>
                </a:gridCol>
                <a:gridCol w="832354">
                  <a:extLst>
                    <a:ext uri="{9D8B030D-6E8A-4147-A177-3AD203B41FA5}">
                      <a16:colId xmlns:a16="http://schemas.microsoft.com/office/drawing/2014/main" val="2114559894"/>
                    </a:ext>
                  </a:extLst>
                </a:gridCol>
                <a:gridCol w="29244">
                  <a:extLst>
                    <a:ext uri="{9D8B030D-6E8A-4147-A177-3AD203B41FA5}">
                      <a16:colId xmlns:a16="http://schemas.microsoft.com/office/drawing/2014/main" val="3524481032"/>
                    </a:ext>
                  </a:extLst>
                </a:gridCol>
                <a:gridCol w="938979">
                  <a:extLst>
                    <a:ext uri="{9D8B030D-6E8A-4147-A177-3AD203B41FA5}">
                      <a16:colId xmlns:a16="http://schemas.microsoft.com/office/drawing/2014/main" val="2934648845"/>
                    </a:ext>
                  </a:extLst>
                </a:gridCol>
              </a:tblGrid>
              <a:tr h="313578">
                <a:tc gridSpan="8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upplementary Table</a:t>
                      </a:r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. Demographics and underlying medical conditions in the IBD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v.s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non-IBD groups (1997-201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393255"/>
                  </a:ext>
                </a:extLst>
              </a:tr>
              <a:tr h="171729">
                <a:tc rowSpan="2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haracteristics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IBD</a:t>
                      </a:r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(n=8,513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non-IBD</a:t>
                      </a:r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(n=25,539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MD </a:t>
                      </a:r>
                    </a:p>
                  </a:txBody>
                  <a:tcPr marL="1922" marR="1922" marT="192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5194940"/>
                  </a:ext>
                </a:extLst>
              </a:tr>
              <a:tr h="16153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N(Mea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D(%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N(Mea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D(%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9811381"/>
                  </a:ext>
                </a:extLst>
              </a:tr>
              <a:tr h="17858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ge, years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35.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3.8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35.3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3.8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5133550"/>
                  </a:ext>
                </a:extLst>
              </a:tr>
              <a:tr h="178968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Gender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9780160"/>
                  </a:ext>
                </a:extLst>
              </a:tr>
              <a:tr h="178968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Mal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33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0.86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2980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0.82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0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256983"/>
                  </a:ext>
                </a:extLst>
              </a:tr>
              <a:tr h="178968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Female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18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9.14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2559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9.18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-0.00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715821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omorbidities</a:t>
                      </a:r>
                      <a:r>
                        <a:rPr lang="en-US" sz="8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微軟正黑體" panose="020B0604030504040204" pitchFamily="34" charset="-120"/>
                          <a:cs typeface="Arial" panose="020B0604020202020204" pitchFamily="34" charset="0"/>
                        </a:rPr>
                        <a:t>, n (%)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8422135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Dyslipidemia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83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.07%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970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63%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01</a:t>
                      </a:r>
                      <a:endParaRPr lang="zh-TW" sz="8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9882758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Hypertension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66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9.57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373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4.63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31</a:t>
                      </a:r>
                      <a:endParaRPr lang="zh-TW" sz="8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9457250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Ischemic heart disease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08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2.76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030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7.95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58</a:t>
                      </a:r>
                      <a:endParaRPr lang="zh-TW" sz="800" kern="10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3998843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COPD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27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5.00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40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9.42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71</a:t>
                      </a:r>
                      <a:endParaRPr lang="zh-TW" sz="8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0830387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Chronic kidney disease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74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8.73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48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.81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13</a:t>
                      </a:r>
                      <a:endParaRPr lang="zh-TW" sz="8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855720"/>
                  </a:ext>
                </a:extLst>
              </a:tr>
              <a:tr h="210105"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 Liver cirrhosis</a:t>
                      </a:r>
                      <a:endParaRPr lang="zh-TW" sz="9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97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3.16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3805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4.90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212</a:t>
                      </a:r>
                      <a:endParaRPr lang="zh-TW" sz="800" kern="100" dirty="0"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05" marR="1905" marT="19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7883345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ases numbers (N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3183100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T1D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73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86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41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5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37 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626681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Rheumatoid arthritis (RA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35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.18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9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.34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04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5612570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ystemic lupus erythematosus (SLE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1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1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4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23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5732835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nkylosing spondylitis (AS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4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75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1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85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7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8569003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Psoriasis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.84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557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.18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42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328540"/>
                  </a:ext>
                </a:extLst>
              </a:tr>
              <a:tr h="210105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Multiple sclerosis (MS)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9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2%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29</a:t>
                      </a: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5668770"/>
                  </a:ext>
                </a:extLst>
              </a:tr>
              <a:tr h="501756">
                <a:tc gridSpan="8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bbreviations: IBD, inflammatory bowel disease; SD: standard deviation; SMD, standardized mean difference; COPD, chronic obstructive pulmonary disease; T1D, type 1 diabetes.</a:t>
                      </a:r>
                    </a:p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MDs are presented to evaluate covariate balance before and after propensity score matching, which included age and sex. An SMD &lt; 0.1 indicates adequate balance, whereas an SMD &gt; 0.1 suggests potential imbalance.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1922" marR="1922" marT="1922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4289632"/>
                  </a:ext>
                </a:extLst>
              </a:tr>
            </a:tbl>
          </a:graphicData>
        </a:graphic>
      </p:graphicFrame>
      <p:sp>
        <p:nvSpPr>
          <p:cNvPr id="3" name="文字方塊 2">
            <a:extLst>
              <a:ext uri="{FF2B5EF4-FFF2-40B4-BE49-F238E27FC236}">
                <a16:creationId xmlns:a16="http://schemas.microsoft.com/office/drawing/2014/main" id="{886ECF4B-02C9-8088-89BB-74FB16AD9D9A}"/>
              </a:ext>
            </a:extLst>
          </p:cNvPr>
          <p:cNvSpPr txBox="1"/>
          <p:nvPr/>
        </p:nvSpPr>
        <p:spPr>
          <a:xfrm>
            <a:off x="2143067" y="244444"/>
            <a:ext cx="2194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25825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74E65B-8BD6-3FFB-ADC1-21BC100FC0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>
            <a:extLst>
              <a:ext uri="{FF2B5EF4-FFF2-40B4-BE49-F238E27FC236}">
                <a16:creationId xmlns:a16="http://schemas.microsoft.com/office/drawing/2014/main" id="{6A2963CF-07C3-BD72-0495-1B001905E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57280" y="5746975"/>
            <a:ext cx="1458039" cy="330641"/>
          </a:xfrm>
        </p:spPr>
        <p:txBody>
          <a:bodyPr/>
          <a:lstStyle/>
          <a:p>
            <a:r>
              <a:rPr lang="en-US" altLang="zh-TW" dirty="0">
                <a:solidFill>
                  <a:schemeClr val="tx1"/>
                </a:solidFill>
              </a:rPr>
              <a:t>5</a:t>
            </a:r>
            <a:endParaRPr lang="zh-TW" altLang="en-US" dirty="0">
              <a:solidFill>
                <a:schemeClr val="tx1"/>
              </a:solidFill>
            </a:endParaRPr>
          </a:p>
        </p:txBody>
      </p:sp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09AE4709-DFC1-1579-42EA-92AF478060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8131609"/>
              </p:ext>
            </p:extLst>
          </p:nvPr>
        </p:nvGraphicFramePr>
        <p:xfrm>
          <a:off x="53667" y="628124"/>
          <a:ext cx="6372839" cy="2920836"/>
        </p:xfrm>
        <a:graphic>
          <a:graphicData uri="http://schemas.openxmlformats.org/drawingml/2006/table">
            <a:tbl>
              <a:tblPr/>
              <a:tblGrid>
                <a:gridCol w="992369">
                  <a:extLst>
                    <a:ext uri="{9D8B030D-6E8A-4147-A177-3AD203B41FA5}">
                      <a16:colId xmlns:a16="http://schemas.microsoft.com/office/drawing/2014/main" val="2081625085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1455903429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3681075751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69104119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3319537115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2608513949"/>
                    </a:ext>
                  </a:extLst>
                </a:gridCol>
                <a:gridCol w="896745">
                  <a:extLst>
                    <a:ext uri="{9D8B030D-6E8A-4147-A177-3AD203B41FA5}">
                      <a16:colId xmlns:a16="http://schemas.microsoft.com/office/drawing/2014/main" val="1659520879"/>
                    </a:ext>
                  </a:extLst>
                </a:gridCol>
              </a:tblGrid>
              <a:tr h="360910">
                <a:tc gridSpan="7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Supplementary 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Table 2.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onditional logistic regression analysis of immune mediated diseases in IBD patients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5A5A5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7095324"/>
                  </a:ext>
                </a:extLst>
              </a:tr>
              <a:tr h="487958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Parameter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rude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OR</a:t>
                      </a:r>
                      <a:r>
                        <a:rPr lang="en-US" sz="8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</a:t>
                      </a:r>
                      <a:endParaRPr lang="en-US" sz="8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P-valu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djusted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OR</a:t>
                      </a:r>
                      <a:r>
                        <a:rPr lang="en-US" sz="8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b</a:t>
                      </a:r>
                      <a:r>
                        <a:rPr lang="zh-TW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95% Confidence Interval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b"/>
                      <a:r>
                        <a:rPr lang="en-US" altLang="zh-TW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P-valu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5913307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T1D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57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18- 2.08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02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54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13 - 2.09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06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4573314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RA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85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61- 2.11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&lt;0.001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71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49- 1.96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2997012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SLE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38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99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92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54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39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99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95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5145528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AS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07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68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.55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&lt;0.001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90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53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2.36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9969904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Psoriasis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31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13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53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27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09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48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02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5219743"/>
                  </a:ext>
                </a:extLst>
              </a:tr>
              <a:tr h="210172"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lvl="0" algn="l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 MS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39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1.53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1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t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9.05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1.69-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48.51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01</a:t>
                      </a:r>
                      <a:r>
                        <a:rPr lang="zh-TW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*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0627049"/>
                  </a:ext>
                </a:extLst>
              </a:tr>
              <a:tr h="810936">
                <a:tc gridSpan="7">
                  <a:txBody>
                    <a:bodyPr/>
                    <a:lstStyle>
                      <a:lvl1pPr marL="0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32401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648035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97205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29607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1620088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1944106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2268123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2592141" algn="l" defTabSz="648035" rtl="0" eaLnBrk="1" latinLnBrk="0" hangingPunct="1">
                        <a:defRPr sz="1276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bbreviations: RA: rheumatoid arthritis; SLE: systemic lupus erythematosus; AS: ankylosing spondylitis; MS: multiple sclerosis; OR: Odds ratio</a:t>
                      </a:r>
                    </a:p>
                    <a:p>
                      <a:pPr marL="342900" indent="-342900" algn="l" fontAlgn="t">
                        <a:buAutoNum type="alphaLcPeriod"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Crude OR of the conditional logistic regression were adjusted for age and gender</a:t>
                      </a:r>
                    </a:p>
                    <a:p>
                      <a:pPr marL="342900" indent="-342900" algn="l" fontAlgn="t">
                        <a:buAutoNum type="alphaLcPeriod"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Adjusted OR of the </a:t>
                      </a:r>
                      <a:r>
                        <a:rPr lang="en-US" altLang="zh-TW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nditional logistic regression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were adjusted for age, gender and multiple comorbidities such as dyslipidemia, hypertension, ischemic heart disease or chronic obstructive pulmonary disease </a:t>
                      </a: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altLang="zh-TW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TW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zh-TW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t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3295" marR="3295" marT="329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85438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0613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>
            <a:extLst>
              <a:ext uri="{FF2B5EF4-FFF2-40B4-BE49-F238E27FC236}">
                <a16:creationId xmlns:a16="http://schemas.microsoft.com/office/drawing/2014/main" id="{B6D8B8DF-5726-B0E4-DFC9-BF88B48A4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022136" y="5930177"/>
            <a:ext cx="1458039" cy="330641"/>
          </a:xfrm>
        </p:spPr>
        <p:txBody>
          <a:bodyPr/>
          <a:lstStyle/>
          <a:p>
            <a:fld id="{C7BF8ACE-5F9E-4525-94E8-A111154E6FB0}" type="slidenum">
              <a:rPr lang="zh-TW" altLang="en-US" smtClean="0"/>
              <a:t>3</a:t>
            </a:fld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AD71D9EC-D114-6702-F002-2F55B30505F9}"/>
              </a:ext>
            </a:extLst>
          </p:cNvPr>
          <p:cNvSpPr txBox="1"/>
          <p:nvPr/>
        </p:nvSpPr>
        <p:spPr>
          <a:xfrm>
            <a:off x="0" y="63782"/>
            <a:ext cx="13272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Supplemental Fig. 1</a:t>
            </a:r>
            <a:endParaRPr lang="zh-TW" altLang="en-US" sz="900" b="1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4A3F13FD-33B4-59B3-3102-24FF38607EA2}"/>
              </a:ext>
            </a:extLst>
          </p:cNvPr>
          <p:cNvSpPr txBox="1"/>
          <p:nvPr/>
        </p:nvSpPr>
        <p:spPr>
          <a:xfrm>
            <a:off x="-1" y="5348526"/>
            <a:ext cx="6480175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dm1 deletion via </a:t>
            </a:r>
            <a:r>
              <a:rPr lang="en-US" altLang="zh-TW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ck</a:t>
            </a:r>
            <a:r>
              <a:rPr lang="en-US" altLang="zh-TW" sz="1000" b="1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e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ed T cell subset composition in both NOD and B6 backgrounds, skewing the CD4:CD8 ratio toward a CD4⁺ predominance.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D CKO mice showed increased IFN-</a:t>
            </a:r>
            <a:r>
              <a:rPr lang="el-GR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⁺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 and IL-17A⁺ Th17 CD4⁺ subsets, with IFN-</a:t>
            </a:r>
            <a:r>
              <a:rPr lang="el-GR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⁺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 cells also elevated in B6 CKO versus WT but not significantly different between NOD CKO and B6 CKO. Both strains exhibited a trend toward higher IFN-</a:t>
            </a:r>
            <a:r>
              <a:rPr lang="el-GR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⁺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L-17A⁺ CD8⁺ T cells. Nonparametric Kruskal–Wallis test was applied as appropriate. (*P &lt; 0.05, ** P &lt; 0.01, *** P &lt; 0.001; ns, not significant).</a:t>
            </a:r>
            <a:endParaRPr lang="zh-TW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群組 12">
            <a:extLst>
              <a:ext uri="{FF2B5EF4-FFF2-40B4-BE49-F238E27FC236}">
                <a16:creationId xmlns:a16="http://schemas.microsoft.com/office/drawing/2014/main" id="{0325B2C2-8ED9-9191-01B2-76716CB7F5E9}"/>
              </a:ext>
            </a:extLst>
          </p:cNvPr>
          <p:cNvGrpSpPr/>
          <p:nvPr/>
        </p:nvGrpSpPr>
        <p:grpSpPr>
          <a:xfrm>
            <a:off x="933050" y="1636544"/>
            <a:ext cx="4881982" cy="2022348"/>
            <a:chOff x="224625" y="343953"/>
            <a:chExt cx="5754372" cy="2615885"/>
          </a:xfrm>
        </p:grpSpPr>
        <p:grpSp>
          <p:nvGrpSpPr>
            <p:cNvPr id="21" name="群組 20">
              <a:extLst>
                <a:ext uri="{FF2B5EF4-FFF2-40B4-BE49-F238E27FC236}">
                  <a16:creationId xmlns:a16="http://schemas.microsoft.com/office/drawing/2014/main" id="{E9D35094-87C9-C53C-C9C2-AA3769EB6571}"/>
                </a:ext>
              </a:extLst>
            </p:cNvPr>
            <p:cNvGrpSpPr/>
            <p:nvPr/>
          </p:nvGrpSpPr>
          <p:grpSpPr>
            <a:xfrm>
              <a:off x="224625" y="530022"/>
              <a:ext cx="5665943" cy="2429816"/>
              <a:chOff x="218809" y="329725"/>
              <a:chExt cx="5665943" cy="2429816"/>
            </a:xfrm>
          </p:grpSpPr>
          <p:sp>
            <p:nvSpPr>
              <p:cNvPr id="5" name="文字方塊 4">
                <a:extLst>
                  <a:ext uri="{FF2B5EF4-FFF2-40B4-BE49-F238E27FC236}">
                    <a16:creationId xmlns:a16="http://schemas.microsoft.com/office/drawing/2014/main" id="{028807EF-BF42-D519-AFDF-86066225EA69}"/>
                  </a:ext>
                </a:extLst>
              </p:cNvPr>
              <p:cNvSpPr txBox="1"/>
              <p:nvPr/>
            </p:nvSpPr>
            <p:spPr>
              <a:xfrm>
                <a:off x="2214592" y="329725"/>
                <a:ext cx="168664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peen</a:t>
                </a:r>
                <a:endParaRPr lang="zh-TW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直線接點 9">
                <a:extLst>
                  <a:ext uri="{FF2B5EF4-FFF2-40B4-BE49-F238E27FC236}">
                    <a16:creationId xmlns:a16="http://schemas.microsoft.com/office/drawing/2014/main" id="{5AF96A9D-6A30-5327-ECC9-A27118F06B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0070" y="573012"/>
                <a:ext cx="5494682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1" name="圖片 10" descr="一張含有 螢幕擷取畫面, 黑暗 的圖片&#10;&#10;AI 產生的內容可能不正確。">
                <a:extLst>
                  <a:ext uri="{FF2B5EF4-FFF2-40B4-BE49-F238E27FC236}">
                    <a16:creationId xmlns:a16="http://schemas.microsoft.com/office/drawing/2014/main" id="{DB4B775F-18AB-1FDA-6FCC-2EE7A3AE4F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8809" y="545169"/>
                <a:ext cx="1819656" cy="2214372"/>
              </a:xfrm>
              <a:prstGeom prst="rect">
                <a:avLst/>
              </a:prstGeom>
            </p:spPr>
          </p:pic>
          <p:pic>
            <p:nvPicPr>
              <p:cNvPr id="15" name="圖片 14" descr="一張含有 螢幕擷取畫面, 黑暗, 設計 的圖片&#10;&#10;AI 產生的內容可能不正確。">
                <a:extLst>
                  <a:ext uri="{FF2B5EF4-FFF2-40B4-BE49-F238E27FC236}">
                    <a16:creationId xmlns:a16="http://schemas.microsoft.com/office/drawing/2014/main" id="{7EF8AE88-B478-4C4D-71D5-109AE66A6C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74440" y="573011"/>
                <a:ext cx="1658112" cy="2022348"/>
              </a:xfrm>
              <a:prstGeom prst="rect">
                <a:avLst/>
              </a:prstGeom>
            </p:spPr>
          </p:pic>
          <p:pic>
            <p:nvPicPr>
              <p:cNvPr id="18" name="圖片 17" descr="一張含有 黑暗, 螢幕擷取畫面, 夜晚 的圖片&#10;&#10;AI 產生的內容可能不正確。">
                <a:extLst>
                  <a:ext uri="{FF2B5EF4-FFF2-40B4-BE49-F238E27FC236}">
                    <a16:creationId xmlns:a16="http://schemas.microsoft.com/office/drawing/2014/main" id="{BF070E54-D783-D631-8830-06B5BDF090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48992" y="573012"/>
                <a:ext cx="1627632" cy="2132076"/>
              </a:xfrm>
              <a:prstGeom prst="rect">
                <a:avLst/>
              </a:prstGeom>
            </p:spPr>
          </p:pic>
        </p:grpSp>
        <p:sp>
          <p:nvSpPr>
            <p:cNvPr id="8" name="文字方塊 14">
              <a:extLst>
                <a:ext uri="{FF2B5EF4-FFF2-40B4-BE49-F238E27FC236}">
                  <a16:creationId xmlns:a16="http://schemas.microsoft.com/office/drawing/2014/main" id="{637F371B-EFAB-4F74-A8B9-701F380B6FDF}"/>
                </a:ext>
              </a:extLst>
            </p:cNvPr>
            <p:cNvSpPr txBox="1"/>
            <p:nvPr/>
          </p:nvSpPr>
          <p:spPr>
            <a:xfrm>
              <a:off x="333011" y="343953"/>
              <a:ext cx="1038860" cy="4572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5000"/>
                </a:lnSpc>
                <a:spcAft>
                  <a:spcPts val="800"/>
                </a:spcAft>
                <a:buNone/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D4</a:t>
              </a:r>
              <a:r>
                <a:rPr lang="en-US" sz="800" b="1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+</a:t>
              </a: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T cells</a:t>
              </a:r>
              <a:endParaRPr lang="zh-TW" sz="1200" kern="100" dirty="0">
                <a:effectLst/>
                <a:latin typeface="Aptos" panose="020B00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  <p:pic>
          <p:nvPicPr>
            <p:cNvPr id="12" name="圖片 11" descr="一張含有 螢幕擷取畫面, 時鐘, 黑暗, 文字 的圖片&#10;&#10;AI 產生的內容可能不正確。">
              <a:extLst>
                <a:ext uri="{FF2B5EF4-FFF2-40B4-BE49-F238E27FC236}">
                  <a16:creationId xmlns:a16="http://schemas.microsoft.com/office/drawing/2014/main" id="{ED92B1C3-AA67-6AD7-88BB-197D5754B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3453" y="773308"/>
              <a:ext cx="1685544" cy="2040636"/>
            </a:xfrm>
            <a:prstGeom prst="rect">
              <a:avLst/>
            </a:prstGeom>
          </p:spPr>
        </p:pic>
      </p:grpSp>
      <p:pic>
        <p:nvPicPr>
          <p:cNvPr id="9" name="圖片 8">
            <a:extLst>
              <a:ext uri="{FF2B5EF4-FFF2-40B4-BE49-F238E27FC236}">
                <a16:creationId xmlns:a16="http://schemas.microsoft.com/office/drawing/2014/main" id="{E5346FD2-442D-BCAD-FF53-9C32C033EF9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299232"/>
            <a:ext cx="3777513" cy="1529807"/>
          </a:xfrm>
          <a:prstGeom prst="rect">
            <a:avLst/>
          </a:prstGeom>
        </p:spPr>
      </p:pic>
      <p:grpSp>
        <p:nvGrpSpPr>
          <p:cNvPr id="16" name="群組 15">
            <a:extLst>
              <a:ext uri="{FF2B5EF4-FFF2-40B4-BE49-F238E27FC236}">
                <a16:creationId xmlns:a16="http://schemas.microsoft.com/office/drawing/2014/main" id="{30D0C2BC-9300-7ADD-9CC9-6A6E712C8BD5}"/>
              </a:ext>
            </a:extLst>
          </p:cNvPr>
          <p:cNvGrpSpPr/>
          <p:nvPr/>
        </p:nvGrpSpPr>
        <p:grpSpPr>
          <a:xfrm>
            <a:off x="1025004" y="3453755"/>
            <a:ext cx="2359544" cy="2021701"/>
            <a:chOff x="837579" y="3466396"/>
            <a:chExt cx="2359544" cy="2021701"/>
          </a:xfrm>
        </p:grpSpPr>
        <p:pic>
          <p:nvPicPr>
            <p:cNvPr id="7" name="圖片 6">
              <a:extLst>
                <a:ext uri="{FF2B5EF4-FFF2-40B4-BE49-F238E27FC236}">
                  <a16:creationId xmlns:a16="http://schemas.microsoft.com/office/drawing/2014/main" id="{7A3986A1-5A37-FE82-2299-81A8DCCB3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5316" y="3466396"/>
              <a:ext cx="2341807" cy="2021701"/>
            </a:xfrm>
            <a:prstGeom prst="rect">
              <a:avLst/>
            </a:prstGeom>
            <a:noFill/>
          </p:spPr>
        </p:pic>
        <p:sp>
          <p:nvSpPr>
            <p:cNvPr id="14" name="文字方塊 14">
              <a:extLst>
                <a:ext uri="{FF2B5EF4-FFF2-40B4-BE49-F238E27FC236}">
                  <a16:creationId xmlns:a16="http://schemas.microsoft.com/office/drawing/2014/main" id="{CF108F69-1E30-3B7A-322C-3496555BA5B0}"/>
                </a:ext>
              </a:extLst>
            </p:cNvPr>
            <p:cNvSpPr txBox="1"/>
            <p:nvPr/>
          </p:nvSpPr>
          <p:spPr>
            <a:xfrm>
              <a:off x="837579" y="3520738"/>
              <a:ext cx="881364" cy="22576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lnSpc>
                  <a:spcPct val="115000"/>
                </a:lnSpc>
                <a:spcAft>
                  <a:spcPts val="800"/>
                </a:spcAft>
                <a:buNone/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D8</a:t>
              </a:r>
              <a:r>
                <a:rPr lang="en-US" sz="800" b="1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+</a:t>
              </a: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 T cells</a:t>
              </a:r>
              <a:endParaRPr lang="zh-TW" sz="1200" kern="100" dirty="0">
                <a:effectLst/>
                <a:latin typeface="Aptos" panose="020B00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群組 24">
            <a:extLst>
              <a:ext uri="{FF2B5EF4-FFF2-40B4-BE49-F238E27FC236}">
                <a16:creationId xmlns:a16="http://schemas.microsoft.com/office/drawing/2014/main" id="{8375544B-7539-114B-2A57-5C189BB4667D}"/>
              </a:ext>
            </a:extLst>
          </p:cNvPr>
          <p:cNvGrpSpPr/>
          <p:nvPr/>
        </p:nvGrpSpPr>
        <p:grpSpPr>
          <a:xfrm>
            <a:off x="3820782" y="36435"/>
            <a:ext cx="2831552" cy="1818964"/>
            <a:chOff x="3820782" y="36435"/>
            <a:chExt cx="2831552" cy="1818964"/>
          </a:xfrm>
        </p:grpSpPr>
        <p:pic>
          <p:nvPicPr>
            <p:cNvPr id="22" name="圖片 21" descr="一張含有 螢幕擷取畫面, 黑暗, 夜晚 的圖片&#10;&#10;AI 產生的內容可能不正確。">
              <a:extLst>
                <a:ext uri="{FF2B5EF4-FFF2-40B4-BE49-F238E27FC236}">
                  <a16:creationId xmlns:a16="http://schemas.microsoft.com/office/drawing/2014/main" id="{23AC8172-7DDF-2703-2265-E162B147635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0782" y="51614"/>
              <a:ext cx="1677658" cy="1803785"/>
            </a:xfrm>
            <a:prstGeom prst="rect">
              <a:avLst/>
            </a:prstGeom>
          </p:spPr>
        </p:pic>
        <p:pic>
          <p:nvPicPr>
            <p:cNvPr id="24" name="圖片 23" descr="一張含有 黑暗, 螢幕擷取畫面, 黑色, 夜晚 的圖片&#10;&#10;AI 產生的內容可能不正確。">
              <a:extLst>
                <a:ext uri="{FF2B5EF4-FFF2-40B4-BE49-F238E27FC236}">
                  <a16:creationId xmlns:a16="http://schemas.microsoft.com/office/drawing/2014/main" id="{848D09FD-1958-A81A-F70D-F4539DEE018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5686" y="36435"/>
              <a:ext cx="1686648" cy="181345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038385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>
            <a:extLst>
              <a:ext uri="{FF2B5EF4-FFF2-40B4-BE49-F238E27FC236}">
                <a16:creationId xmlns:a16="http://schemas.microsoft.com/office/drawing/2014/main" id="{99AC4A21-CE6B-F82B-1111-9CE2B6489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4</a:t>
            </a:fld>
            <a:endParaRPr lang="zh-TW" altLang="en-US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D6C29182-09DD-9159-318F-5CCB1A8B8E2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615" y="336039"/>
            <a:ext cx="5723255" cy="2123440"/>
          </a:xfrm>
          <a:prstGeom prst="rect">
            <a:avLst/>
          </a:prstGeom>
          <a:noFill/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6C56B3C2-4A18-0A93-E0ED-47AD321910CB}"/>
              </a:ext>
            </a:extLst>
          </p:cNvPr>
          <p:cNvSpPr txBox="1"/>
          <p:nvPr/>
        </p:nvSpPr>
        <p:spPr>
          <a:xfrm>
            <a:off x="0" y="63782"/>
            <a:ext cx="13272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Supplemental Fig. 2</a:t>
            </a:r>
            <a:endParaRPr lang="zh-TW" altLang="en-US" sz="900" b="1" dirty="0"/>
          </a:p>
        </p:txBody>
      </p:sp>
      <p:pic>
        <p:nvPicPr>
          <p:cNvPr id="6" name="圖片 5" descr="一張含有 螢幕擷取畫面 的圖片&#10;&#10;AI 產生的內容可能不正確。">
            <a:extLst>
              <a:ext uri="{FF2B5EF4-FFF2-40B4-BE49-F238E27FC236}">
                <a16:creationId xmlns:a16="http://schemas.microsoft.com/office/drawing/2014/main" id="{385A6E13-BE20-2C9E-0F8A-CCF63251E1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0" y="2661603"/>
            <a:ext cx="2543175" cy="23241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字方塊 8">
            <a:extLst>
              <a:ext uri="{FF2B5EF4-FFF2-40B4-BE49-F238E27FC236}">
                <a16:creationId xmlns:a16="http://schemas.microsoft.com/office/drawing/2014/main" id="{B24F4D99-968C-F483-D692-906AF159DA5B}"/>
              </a:ext>
            </a:extLst>
          </p:cNvPr>
          <p:cNvSpPr txBox="1"/>
          <p:nvPr/>
        </p:nvSpPr>
        <p:spPr>
          <a:xfrm>
            <a:off x="0" y="5093867"/>
            <a:ext cx="648017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DE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 vitro suppression assay of splenic Tregs from 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6.</a:t>
            </a:r>
            <a:r>
              <a:rPr lang="de-DE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dm1</a:t>
            </a:r>
            <a:r>
              <a:rPr lang="de-DE" altLang="zh-TW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/F</a:t>
            </a:r>
            <a:r>
              <a:rPr lang="de-DE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6</a:t>
            </a:r>
            <a:r>
              <a:rPr lang="de-DE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de-DE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k</a:t>
            </a:r>
            <a:r>
              <a:rPr lang="de-DE" altLang="zh-TW" sz="10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</a:t>
            </a:r>
            <a:r>
              <a:rPr lang="de-DE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dm1</a:t>
            </a:r>
            <a:r>
              <a:rPr lang="de-DE" altLang="zh-TW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/F</a:t>
            </a:r>
            <a:r>
              <a:rPr lang="de-DE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</a:t>
            </a:r>
            <a:r>
              <a:rPr lang="zh-TW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4-6)</a:t>
            </a:r>
            <a:r>
              <a:rPr lang="de-DE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Data are shown as mean ± SEM from at least three independent experiments. Statistical significance was determined using the nonparametric Mann–Whitney U test for datasets deviating from normality. (*</a:t>
            </a:r>
            <a:r>
              <a:rPr lang="en-US" altLang="zh-TW" sz="1000" i="1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zh-TW" sz="10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&lt; 0.05, **</a:t>
            </a:r>
            <a:r>
              <a:rPr lang="en-US" altLang="zh-TW" sz="1000" i="1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P</a:t>
            </a:r>
            <a:r>
              <a:rPr lang="en-US" altLang="zh-TW" sz="10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&lt; 0.01, ***</a:t>
            </a:r>
            <a:r>
              <a:rPr lang="en-US" altLang="zh-TW" sz="1000" i="1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P</a:t>
            </a:r>
            <a:r>
              <a:rPr lang="en-US" altLang="zh-TW" sz="10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&lt; 0.001; ns, not significant).</a:t>
            </a:r>
            <a:endParaRPr lang="zh-TW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圖片 6" descr="一張含有 螢幕擷取畫面 的圖片&#10;&#10;AI 產生的內容可能不正確。">
            <a:extLst>
              <a:ext uri="{FF2B5EF4-FFF2-40B4-BE49-F238E27FC236}">
                <a16:creationId xmlns:a16="http://schemas.microsoft.com/office/drawing/2014/main" id="{17595298-F89E-361E-9A2B-D9689ECF900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020" y="2711133"/>
            <a:ext cx="3973195" cy="222504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8803883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>
            <a:extLst>
              <a:ext uri="{FF2B5EF4-FFF2-40B4-BE49-F238E27FC236}">
                <a16:creationId xmlns:a16="http://schemas.microsoft.com/office/drawing/2014/main" id="{D60FFF30-7454-1ACB-00C5-079310CC9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F8ACE-5F9E-4525-94E8-A111154E6FB0}" type="slidenum">
              <a:rPr lang="zh-TW" altLang="en-US" smtClean="0"/>
              <a:t>5</a:t>
            </a:fld>
            <a:endParaRPr lang="zh-TW" altLang="en-US"/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id="{A199A77A-C462-885A-A857-1EAE00D4BA76}"/>
              </a:ext>
            </a:extLst>
          </p:cNvPr>
          <p:cNvGrpSpPr/>
          <p:nvPr/>
        </p:nvGrpSpPr>
        <p:grpSpPr>
          <a:xfrm>
            <a:off x="1832651" y="854327"/>
            <a:ext cx="2362200" cy="4248150"/>
            <a:chOff x="0" y="0"/>
            <a:chExt cx="2362200" cy="4248150"/>
          </a:xfrm>
        </p:grpSpPr>
        <p:grpSp>
          <p:nvGrpSpPr>
            <p:cNvPr id="4" name="群組 3">
              <a:extLst>
                <a:ext uri="{FF2B5EF4-FFF2-40B4-BE49-F238E27FC236}">
                  <a16:creationId xmlns:a16="http://schemas.microsoft.com/office/drawing/2014/main" id="{715433F2-DB47-97F4-EDD5-23D8A0D9FB95}"/>
                </a:ext>
              </a:extLst>
            </p:cNvPr>
            <p:cNvGrpSpPr/>
            <p:nvPr/>
          </p:nvGrpSpPr>
          <p:grpSpPr>
            <a:xfrm>
              <a:off x="0" y="0"/>
              <a:ext cx="2362200" cy="4248150"/>
              <a:chOff x="0" y="0"/>
              <a:chExt cx="2362200" cy="4248150"/>
            </a:xfrm>
          </p:grpSpPr>
          <p:sp>
            <p:nvSpPr>
              <p:cNvPr id="6" name="文字方塊 60">
                <a:extLst>
                  <a:ext uri="{FF2B5EF4-FFF2-40B4-BE49-F238E27FC236}">
                    <a16:creationId xmlns:a16="http://schemas.microsoft.com/office/drawing/2014/main" id="{EDB6C12D-DC0F-C046-D3EB-11EB6CC62A51}"/>
                  </a:ext>
                </a:extLst>
              </p:cNvPr>
              <p:cNvSpPr txBox="1"/>
              <p:nvPr/>
            </p:nvSpPr>
            <p:spPr>
              <a:xfrm>
                <a:off x="695325" y="0"/>
                <a:ext cx="1447800" cy="36195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800"/>
                  </a:spcAft>
                  <a:buNone/>
                </a:pPr>
                <a:r>
                  <a:rPr lang="en-US" sz="1000" b="1" kern="100" dirty="0">
                    <a:effectLst/>
                    <a:latin typeface="Arial" panose="020B0604020202020204" pitchFamily="34" charset="0"/>
                    <a:ea typeface="新細明體" panose="02020500000000000000" pitchFamily="18" charset="-120"/>
                    <a:cs typeface="Times New Roman" panose="02020603050405020304" pitchFamily="18" charset="0"/>
                  </a:rPr>
                  <a:t>T1D vs HC</a:t>
                </a:r>
                <a:endParaRPr lang="zh-TW" sz="1200" kern="100" dirty="0">
                  <a:effectLst/>
                  <a:latin typeface="Aptos" panose="020B0004020202020204" pitchFamily="34" charset="0"/>
                  <a:ea typeface="新細明體" panose="02020500000000000000" pitchFamily="18" charset="-12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" name="圖片 6" descr="一張含有 鮮豔, 螢幕擷取畫面, Rectangle, 藝術 的圖片&#10;&#10;AI 產生的內容可能不正確。">
                <a:extLst>
                  <a:ext uri="{FF2B5EF4-FFF2-40B4-BE49-F238E27FC236}">
                    <a16:creationId xmlns:a16="http://schemas.microsoft.com/office/drawing/2014/main" id="{EBC2117E-FD00-EB9B-AED0-69C1DDDA45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142875"/>
                <a:ext cx="2362200" cy="4105275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1E185C70-FB11-2CF9-41BB-757C36474DB9}"/>
                </a:ext>
              </a:extLst>
            </p:cNvPr>
            <p:cNvSpPr/>
            <p:nvPr/>
          </p:nvSpPr>
          <p:spPr>
            <a:xfrm>
              <a:off x="1076325" y="3905250"/>
              <a:ext cx="752475" cy="2190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zh-TW" altLang="en-US"/>
            </a:p>
          </p:txBody>
        </p:sp>
      </p:grpSp>
      <p:sp>
        <p:nvSpPr>
          <p:cNvPr id="8" name="文字方塊 7">
            <a:extLst>
              <a:ext uri="{FF2B5EF4-FFF2-40B4-BE49-F238E27FC236}">
                <a16:creationId xmlns:a16="http://schemas.microsoft.com/office/drawing/2014/main" id="{77DA7573-1109-C000-BCD6-3ABA786FB869}"/>
              </a:ext>
            </a:extLst>
          </p:cNvPr>
          <p:cNvSpPr txBox="1"/>
          <p:nvPr/>
        </p:nvSpPr>
        <p:spPr>
          <a:xfrm>
            <a:off x="0" y="63782"/>
            <a:ext cx="13272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Supplemental Fig. </a:t>
            </a:r>
            <a:r>
              <a:rPr lang="en-US" altLang="zh-TW" sz="900" b="1"/>
              <a:t>3</a:t>
            </a:r>
            <a:endParaRPr lang="zh-TW" altLang="en-US" sz="900" b="1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A10E7F8B-F33C-DA26-C6ED-D8CC03BCD280}"/>
              </a:ext>
            </a:extLst>
          </p:cNvPr>
          <p:cNvSpPr txBox="1"/>
          <p:nvPr/>
        </p:nvSpPr>
        <p:spPr>
          <a:xfrm>
            <a:off x="1" y="5175213"/>
            <a:ext cx="6480174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</a:t>
            </a:r>
            <a:r>
              <a:rPr lang="de-DE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eatmap of RNA expression from 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cly available whole-blood RNA transcriptomic data (GSE123658) comprising 39 T1D patients and 43 healthy controls. 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: T1D: type 1 diabetes; HC: healthy controls</a:t>
            </a:r>
            <a:endParaRPr lang="zh-TW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440503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佈景主題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</TotalTime>
  <Words>750</Words>
  <Application>Microsoft Office PowerPoint</Application>
  <PresentationFormat>自訂</PresentationFormat>
  <Paragraphs>185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1_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W Tsai</dc:creator>
  <cp:lastModifiedBy>YW Tsai</cp:lastModifiedBy>
  <cp:revision>4</cp:revision>
  <dcterms:created xsi:type="dcterms:W3CDTF">2025-02-28T10:24:56Z</dcterms:created>
  <dcterms:modified xsi:type="dcterms:W3CDTF">2025-09-14T12:31:10Z</dcterms:modified>
</cp:coreProperties>
</file>